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2" autoAdjust="0"/>
    <p:restoredTop sz="94660"/>
  </p:normalViewPr>
  <p:slideViewPr>
    <p:cSldViewPr snapToGrid="0">
      <p:cViewPr varScale="1">
        <p:scale>
          <a:sx n="79" d="100"/>
          <a:sy n="79" d="100"/>
        </p:scale>
        <p:origin x="308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963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246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046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022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766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369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899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706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969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173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8283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  <a:t>6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8620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>
            <a:extLst>
              <a:ext uri="{FF2B5EF4-FFF2-40B4-BE49-F238E27FC236}">
                <a16:creationId xmlns:a16="http://schemas.microsoft.com/office/drawing/2014/main" id="{A7758EEA-DFC1-F94D-006E-615BA90074A4}"/>
              </a:ext>
            </a:extLst>
          </p:cNvPr>
          <p:cNvGrpSpPr/>
          <p:nvPr/>
        </p:nvGrpSpPr>
        <p:grpSpPr>
          <a:xfrm>
            <a:off x="432374" y="491304"/>
            <a:ext cx="5993252" cy="3753146"/>
            <a:chOff x="483223" y="491304"/>
            <a:chExt cx="5993252" cy="3753146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ED7971BE-29B8-24B1-40B6-9B67060F76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3449" r="3852" b="8508"/>
            <a:stretch/>
          </p:blipFill>
          <p:spPr>
            <a:xfrm>
              <a:off x="483223" y="518614"/>
              <a:ext cx="1458427" cy="182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EDA53548-86F2-171A-2665-4099348D39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3260" r="4110" b="8319"/>
            <a:stretch/>
          </p:blipFill>
          <p:spPr>
            <a:xfrm>
              <a:off x="1992536" y="518614"/>
              <a:ext cx="1463040" cy="182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81AB86A3-91C8-957E-E5B4-E4DF8BDB79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3637" r="4627" b="8319"/>
            <a:stretch/>
          </p:blipFill>
          <p:spPr>
            <a:xfrm>
              <a:off x="3504122" y="518614"/>
              <a:ext cx="1463040" cy="182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B91C501E-6A0E-E4BA-92EB-0F9A952BAC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3637" r="4110" b="8696"/>
            <a:stretch/>
          </p:blipFill>
          <p:spPr>
            <a:xfrm>
              <a:off x="5015708" y="518614"/>
              <a:ext cx="1460767" cy="182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F92D672B-5FB6-1475-2CD4-E4BE1CA72C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3692" r="4952" b="8829"/>
            <a:stretch/>
          </p:blipFill>
          <p:spPr>
            <a:xfrm>
              <a:off x="483223" y="2415650"/>
              <a:ext cx="1463040" cy="182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815E9198-3102-20CC-CB6F-A71BE74D40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3692" r="5026" b="9018"/>
            <a:stretch/>
          </p:blipFill>
          <p:spPr>
            <a:xfrm>
              <a:off x="1992536" y="2415650"/>
              <a:ext cx="1463040" cy="182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73D2B035-99C7-3A0E-FA56-B66F64A60C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t="3449" r="4627" b="8319"/>
            <a:stretch/>
          </p:blipFill>
          <p:spPr>
            <a:xfrm>
              <a:off x="3504122" y="2402002"/>
              <a:ext cx="1460767" cy="182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A66101C-B036-B586-1117-036AA3FAF755}"/>
                </a:ext>
              </a:extLst>
            </p:cNvPr>
            <p:cNvSpPr txBox="1"/>
            <p:nvPr/>
          </p:nvSpPr>
          <p:spPr>
            <a:xfrm>
              <a:off x="663240" y="491304"/>
              <a:ext cx="8229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biquitin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FD7AA4B-CEA8-8D73-A001-98487C393136}"/>
                </a:ext>
              </a:extLst>
            </p:cNvPr>
            <p:cNvSpPr txBox="1"/>
            <p:nvPr/>
          </p:nvSpPr>
          <p:spPr>
            <a:xfrm>
              <a:off x="2166773" y="491304"/>
              <a:ext cx="8229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8A1E09A-0808-47E5-7848-09CEB4F83890}"/>
                </a:ext>
              </a:extLst>
            </p:cNvPr>
            <p:cNvSpPr txBox="1"/>
            <p:nvPr/>
          </p:nvSpPr>
          <p:spPr>
            <a:xfrm>
              <a:off x="3711248" y="491304"/>
              <a:ext cx="6400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7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7211FBC-BEB8-8D52-1DC3-F910A8B69CC7}"/>
                </a:ext>
              </a:extLst>
            </p:cNvPr>
            <p:cNvSpPr txBox="1"/>
            <p:nvPr/>
          </p:nvSpPr>
          <p:spPr>
            <a:xfrm>
              <a:off x="5214774" y="491304"/>
              <a:ext cx="6400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P2A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930F488-C528-798C-AAC8-4ACD1B68CADD}"/>
                </a:ext>
              </a:extLst>
            </p:cNvPr>
            <p:cNvSpPr txBox="1"/>
            <p:nvPr/>
          </p:nvSpPr>
          <p:spPr>
            <a:xfrm>
              <a:off x="658689" y="2388348"/>
              <a:ext cx="6400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1B1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C7652F7-B835-6B09-3D7E-D817B2AED9F1}"/>
                </a:ext>
              </a:extLst>
            </p:cNvPr>
            <p:cNvSpPr txBox="1"/>
            <p:nvPr/>
          </p:nvSpPr>
          <p:spPr>
            <a:xfrm>
              <a:off x="2162218" y="2388348"/>
              <a:ext cx="6400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1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ECBA91B-E80D-D5C2-B3F7-E7FC89763590}"/>
                </a:ext>
              </a:extLst>
            </p:cNvPr>
            <p:cNvSpPr txBox="1"/>
            <p:nvPr/>
          </p:nvSpPr>
          <p:spPr>
            <a:xfrm>
              <a:off x="3679396" y="2388348"/>
              <a:ext cx="5486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ub4</a:t>
              </a:r>
            </a:p>
          </p:txBody>
        </p:sp>
      </p:grpSp>
      <p:sp>
        <p:nvSpPr>
          <p:cNvPr id="29" name="TextBox 66">
            <a:extLst>
              <a:ext uri="{FF2B5EF4-FFF2-40B4-BE49-F238E27FC236}">
                <a16:creationId xmlns:a16="http://schemas.microsoft.com/office/drawing/2014/main" id="{8552CF74-5E88-F50B-FAD6-9D2B249E72D7}"/>
              </a:ext>
            </a:extLst>
          </p:cNvPr>
          <p:cNvSpPr txBox="1"/>
          <p:nvPr/>
        </p:nvSpPr>
        <p:spPr>
          <a:xfrm>
            <a:off x="244550" y="4722168"/>
            <a:ext cx="63689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t curve analysis of seven housekeeping genes to evaluate the specificity of primer to generate a single amplicon during RT-qPCR.</a:t>
            </a:r>
          </a:p>
        </p:txBody>
      </p:sp>
    </p:spTree>
    <p:extLst>
      <p:ext uri="{BB962C8B-B14F-4D97-AF65-F5344CB8AC3E}">
        <p14:creationId xmlns:p14="http://schemas.microsoft.com/office/powerpoint/2010/main" val="3072013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31</TotalTime>
  <Words>32</Words>
  <Application>Microsoft Office PowerPoint</Application>
  <PresentationFormat>A4 Paper (210x297 mm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2022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>Mogilicherla Kanakachari</dc:creator>
  <cp:lastModifiedBy>MDPI</cp:lastModifiedBy>
  <cp:revision>4</cp:revision>
  <dcterms:created xsi:type="dcterms:W3CDTF">2024-05-09T06:43:12Z</dcterms:created>
  <dcterms:modified xsi:type="dcterms:W3CDTF">2024-06-01T09:03:54Z</dcterms:modified>
</cp:coreProperties>
</file>